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wmf" ContentType="image/x-wmf"/>
  <Override PartName="/ppt/media/image13.wmf" ContentType="image/x-wmf"/>
  <Override PartName="/ppt/media/image8.wmf" ContentType="image/x-wmf"/>
  <Override PartName="/ppt/media/image12.wmf" ContentType="image/x-wmf"/>
  <Override PartName="/ppt/media/image7.wmf" ContentType="image/x-wmf"/>
  <Override PartName="/ppt/media/image11.wmf" ContentType="image/x-wmf"/>
  <Override PartName="/ppt/media/image6.wmf" ContentType="image/x-wmf"/>
  <Override PartName="/ppt/media/image10.wmf" ContentType="image/x-wmf"/>
  <Override PartName="/ppt/media/image5.wmf" ContentType="image/x-wmf"/>
  <Override PartName="/ppt/media/image4.wmf" ContentType="image/x-wmf"/>
  <Override PartName="/ppt/media/image3.wmf" ContentType="image/x-wmf"/>
  <Override PartName="/ppt/media/image23.wmf" ContentType="image/x-wmf"/>
  <Override PartName="/ppt/media/image22.wmf" ContentType="image/x-wmf"/>
  <Override PartName="/ppt/media/image21.wmf" ContentType="image/x-wmf"/>
  <Override PartName="/ppt/media/image19.wmf" ContentType="image/x-wmf"/>
  <Override PartName="/ppt/media/image20.wmf" ContentType="image/x-wmf"/>
  <Override PartName="/ppt/media/image18.wmf" ContentType="image/x-wmf"/>
  <Override PartName="/ppt/media/image17.wmf" ContentType="image/x-wmf"/>
  <Override PartName="/ppt/media/image16.wmf" ContentType="image/x-wmf"/>
  <Override PartName="/ppt/media/image15.wmf" ContentType="image/x-wmf"/>
  <Override PartName="/ppt/media/image14.wmf" ContentType="image/x-wmf"/>
  <Override PartName="/ppt/media/image1.wmf" ContentType="image/x-wmf"/>
  <Override PartName="/ppt/media/image24.wmf" ContentType="image/x-wmf"/>
  <Override PartName="/ppt/media/image2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13716000" cy="17373600"/>
  <p:notesSz cx="6889750" cy="100218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90400" cy="10022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86200" cy="50328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t">
            <a:noAutofit/>
          </a:bodyPr>
          <a:p>
            <a:pPr indent="0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901680" y="0"/>
            <a:ext cx="2986200" cy="50328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t">
            <a:noAutofit/>
          </a:bodyPr>
          <a:lstStyle>
            <a:lvl1pPr indent="0" algn="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  <a:defRPr b="0" lang="el-GR" sz="13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l-GR" sz="13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09600" y="1252080"/>
            <a:ext cx="2670120" cy="33829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6480" rIns="96480" tIns="48240" bIns="4824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85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9040" y="4822920"/>
            <a:ext cx="5511600" cy="394632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9518760"/>
            <a:ext cx="2986200" cy="50328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b">
            <a:noAutofit/>
          </a:bodyPr>
          <a:p>
            <a:pPr indent="0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901680" y="9518760"/>
            <a:ext cx="2986200" cy="50328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b">
            <a:noAutofit/>
          </a:bodyPr>
          <a:lstStyle>
            <a:lvl1pPr indent="0" algn="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  <a:defRPr b="0" lang="el-GR" sz="13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fld id="{045477DA-EB72-4CC2-8C1B-29A136D29E2E}" type="slidenum">
              <a:rPr b="0" lang="el-GR" sz="13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0" name="PlaceHolder 1"/>
          <p:cNvSpPr>
            <a:spLocks noGrp="1"/>
          </p:cNvSpPr>
          <p:nvPr>
            <p:ph type="sldImg"/>
          </p:nvPr>
        </p:nvSpPr>
        <p:spPr>
          <a:xfrm>
            <a:off x="2109960" y="1252440"/>
            <a:ext cx="2670120" cy="3382920"/>
          </a:xfrm>
          <a:prstGeom prst="rect">
            <a:avLst/>
          </a:prstGeom>
          <a:ln w="0">
            <a:noFill/>
          </a:ln>
        </p:spPr>
      </p:sp>
      <p:sp>
        <p:nvSpPr>
          <p:cNvPr id="121" name="PlaceHolder 2"/>
          <p:cNvSpPr>
            <a:spLocks noGrp="1"/>
          </p:cNvSpPr>
          <p:nvPr>
            <p:ph type="body"/>
          </p:nvPr>
        </p:nvSpPr>
        <p:spPr>
          <a:xfrm>
            <a:off x="689040" y="4822920"/>
            <a:ext cx="5511600" cy="3946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Θέση αριθμού διαφάνειας 3"/>
          <p:cNvSpPr/>
          <p:nvPr/>
        </p:nvSpPr>
        <p:spPr>
          <a:xfrm>
            <a:off x="3902040" y="9518760"/>
            <a:ext cx="2986200" cy="503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 algn="r"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fld id="{C94F3C3D-DC36-48ED-B0B7-BB9AC951D137}" type="slidenum">
              <a:rPr b="0" lang="el-GR" sz="13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BA634C-D2C2-4D4A-86C5-4866D4974B0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4053960"/>
            <a:ext cx="1234440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10042200"/>
            <a:ext cx="1234440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90DDE4-A415-4B33-8A66-32EE2DBBAB6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405396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7011360" y="405396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1004220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7011360" y="1004220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AC2F2F-84A7-480B-BE8B-FD064F5F807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4053960"/>
            <a:ext cx="397476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859640" y="4053960"/>
            <a:ext cx="397476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9033480" y="4053960"/>
            <a:ext cx="397476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10042200"/>
            <a:ext cx="397476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859640" y="10042200"/>
            <a:ext cx="397476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9033480" y="10042200"/>
            <a:ext cx="397476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5616C6-C99B-4A1B-AC1B-73C8B481B9A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4053960"/>
            <a:ext cx="12344400" cy="11464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551"/>
              </a:spcBef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8D94FB-B61D-4104-AB17-8D7BD088C30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4053960"/>
            <a:ext cx="12344400" cy="1146492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5D492D-3AC7-4878-AC72-957F315E49E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4053960"/>
            <a:ext cx="6023880" cy="1146492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7011360" y="4053960"/>
            <a:ext cx="6023880" cy="1146492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B5EC2F-B1E6-4053-9394-F393A581689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3745BA-A1FE-404F-ACB0-29EABC0A255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95160"/>
            <a:ext cx="12344400" cy="13424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551"/>
              </a:spcBef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07F5FE-64AC-4B0C-8205-ED2984B448B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405396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7011360" y="4053960"/>
            <a:ext cx="6023880" cy="1146492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1004220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A7FDAA-1F6D-4D97-8CAA-96C9BE87A8F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4053960"/>
            <a:ext cx="6023880" cy="1146492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7011360" y="405396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7011360" y="1004220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AA7D4A-D3D3-45A2-AB0A-6BEAB2BA67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405396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7011360" y="405396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10042200"/>
            <a:ext cx="1234440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19A1DC-51A2-478D-9B63-4AD67F233A2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85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4053960"/>
            <a:ext cx="12344400" cy="1146492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marL="665280" indent="-665280">
              <a:spcBef>
                <a:spcPts val="1551"/>
              </a:spcBef>
              <a:buClr>
                <a:srgbClr val="000000"/>
              </a:buClr>
              <a:buFont typeface="Arial"/>
              <a:buChar char="•"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  <a:p>
            <a:pPr lvl="1" marL="1442880" indent="-554040">
              <a:spcBef>
                <a:spcPts val="1551"/>
              </a:spcBef>
              <a:buClr>
                <a:srgbClr val="000000"/>
              </a:buClr>
              <a:buFont typeface="Arial"/>
              <a:buChar char="–"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  <a:p>
            <a:pPr lvl="2" marL="2219400" indent="-443160">
              <a:spcBef>
                <a:spcPts val="1551"/>
              </a:spcBef>
              <a:buClr>
                <a:srgbClr val="000000"/>
              </a:buClr>
              <a:buFont typeface="Arial"/>
              <a:buChar char="•"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  <a:p>
            <a:pPr lvl="3" marL="3108240" indent="-442800">
              <a:spcBef>
                <a:spcPts val="1551"/>
              </a:spcBef>
              <a:buClr>
                <a:srgbClr val="000000"/>
              </a:buClr>
              <a:buFont typeface="Arial"/>
              <a:buChar char="–"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  <a:p>
            <a:pPr lvl="4" marL="3995640" indent="-442800">
              <a:spcBef>
                <a:spcPts val="1551"/>
              </a:spcBef>
              <a:buClr>
                <a:srgbClr val="000000"/>
              </a:buClr>
              <a:buFont typeface="Arial"/>
              <a:buChar char="»"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  <a:p>
            <a:pPr lvl="5" marL="3995640" indent="-442800">
              <a:spcBef>
                <a:spcPts val="1551"/>
              </a:spcBef>
              <a:buClr>
                <a:srgbClr val="000000"/>
              </a:buClr>
              <a:buFont typeface="Arial"/>
              <a:buChar char="»"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  <a:p>
            <a:pPr lvl="6" marL="3995640" indent="-442800">
              <a:spcBef>
                <a:spcPts val="1551"/>
              </a:spcBef>
              <a:buClr>
                <a:srgbClr val="000000"/>
              </a:buClr>
              <a:buFont typeface="Arial"/>
              <a:buChar char="»"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16101720"/>
            <a:ext cx="3200400" cy="92556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  <a:defRPr b="0" lang="en-US" sz="23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23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686120" y="16101720"/>
            <a:ext cx="4343400" cy="92556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9829800" y="16101720"/>
            <a:ext cx="3200400" cy="92556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  <a:defRPr b="0" lang="en-US" sz="23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fld id="{03F73BCC-FAEF-4053-B079-8D842B46A2CE}" type="slidenum">
              <a:rPr b="0" lang="en-US" sz="23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image" Target="../media/image6.wmf"/><Relationship Id="rId7" Type="http://schemas.openxmlformats.org/officeDocument/2006/relationships/image" Target="../media/image7.wmf"/><Relationship Id="rId8" Type="http://schemas.openxmlformats.org/officeDocument/2006/relationships/image" Target="../media/image8.wmf"/><Relationship Id="rId9" Type="http://schemas.openxmlformats.org/officeDocument/2006/relationships/image" Target="../media/image9.wmf"/><Relationship Id="rId10" Type="http://schemas.openxmlformats.org/officeDocument/2006/relationships/image" Target="../media/image10.wmf"/><Relationship Id="rId11" Type="http://schemas.openxmlformats.org/officeDocument/2006/relationships/image" Target="../media/image11.wmf"/><Relationship Id="rId12" Type="http://schemas.openxmlformats.org/officeDocument/2006/relationships/image" Target="../media/image12.wmf"/><Relationship Id="rId13" Type="http://schemas.openxmlformats.org/officeDocument/2006/relationships/image" Target="../media/image13.wmf"/><Relationship Id="rId14" Type="http://schemas.openxmlformats.org/officeDocument/2006/relationships/image" Target="../media/image14.wmf"/><Relationship Id="rId15" Type="http://schemas.openxmlformats.org/officeDocument/2006/relationships/image" Target="../media/image15.wmf"/><Relationship Id="rId16" Type="http://schemas.openxmlformats.org/officeDocument/2006/relationships/image" Target="../media/image16.wmf"/><Relationship Id="rId17" Type="http://schemas.openxmlformats.org/officeDocument/2006/relationships/image" Target="../media/image17.wmf"/><Relationship Id="rId18" Type="http://schemas.openxmlformats.org/officeDocument/2006/relationships/image" Target="../media/image18.wmf"/><Relationship Id="rId19" Type="http://schemas.openxmlformats.org/officeDocument/2006/relationships/image" Target="../media/image19.wmf"/><Relationship Id="rId20" Type="http://schemas.openxmlformats.org/officeDocument/2006/relationships/image" Target="../media/image20.wmf"/><Relationship Id="rId21" Type="http://schemas.openxmlformats.org/officeDocument/2006/relationships/image" Target="../media/image21.wmf"/><Relationship Id="rId22" Type="http://schemas.openxmlformats.org/officeDocument/2006/relationships/image" Target="../media/image22.wmf"/><Relationship Id="rId23" Type="http://schemas.openxmlformats.org/officeDocument/2006/relationships/image" Target="../media/image23.wmf"/><Relationship Id="rId24" Type="http://schemas.openxmlformats.org/officeDocument/2006/relationships/image" Target="../media/image24.wmf"/><Relationship Id="rId25" Type="http://schemas.openxmlformats.org/officeDocument/2006/relationships/slideLayout" Target="../slideLayouts/slideLayout1.xml"/><Relationship Id="rId26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Ομάδα 1"/>
          <p:cNvGrpSpPr/>
          <p:nvPr/>
        </p:nvGrpSpPr>
        <p:grpSpPr>
          <a:xfrm>
            <a:off x="171360" y="154080"/>
            <a:ext cx="13285800" cy="15444720"/>
            <a:chOff x="171360" y="154080"/>
            <a:chExt cx="13285800" cy="15444720"/>
          </a:xfrm>
        </p:grpSpPr>
        <p:grpSp>
          <p:nvGrpSpPr>
            <p:cNvPr id="49" name="Group 43"/>
            <p:cNvGrpSpPr/>
            <p:nvPr/>
          </p:nvGrpSpPr>
          <p:grpSpPr>
            <a:xfrm>
              <a:off x="1569600" y="9704880"/>
              <a:ext cx="5094000" cy="730080"/>
              <a:chOff x="1569600" y="9704880"/>
              <a:chExt cx="5094000" cy="730080"/>
            </a:xfrm>
          </p:grpSpPr>
          <p:sp>
            <p:nvSpPr>
              <p:cNvPr id="50" name="TextBox 25"/>
              <p:cNvSpPr/>
              <p:nvPr/>
            </p:nvSpPr>
            <p:spPr>
              <a:xfrm>
                <a:off x="1569600" y="10156320"/>
                <a:ext cx="688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776240"/>
                    <a:tab algn="l" pos="3552840"/>
                    <a:tab algn="l" pos="5329080"/>
                    <a:tab algn="l" pos="7105680"/>
                    <a:tab algn="l" pos="8881920"/>
                    <a:tab algn="l" pos="1065852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ontrol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TextBox 26"/>
              <p:cNvSpPr/>
              <p:nvPr/>
            </p:nvSpPr>
            <p:spPr>
              <a:xfrm>
                <a:off x="3890880" y="10158480"/>
                <a:ext cx="5097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776240"/>
                    <a:tab algn="l" pos="3552840"/>
                    <a:tab algn="l" pos="5329080"/>
                    <a:tab algn="l" pos="7105680"/>
                    <a:tab algn="l" pos="8881920"/>
                    <a:tab algn="l" pos="1065852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DXR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TextBox 27"/>
              <p:cNvSpPr/>
              <p:nvPr/>
            </p:nvSpPr>
            <p:spPr>
              <a:xfrm>
                <a:off x="5838120" y="10156320"/>
                <a:ext cx="8254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776240"/>
                    <a:tab algn="l" pos="3552840"/>
                    <a:tab algn="l" pos="5329080"/>
                    <a:tab algn="l" pos="7105680"/>
                    <a:tab algn="l" pos="8881920"/>
                    <a:tab algn="l" pos="1065852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TS/DXR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TextBox 31"/>
              <p:cNvSpPr/>
              <p:nvPr/>
            </p:nvSpPr>
            <p:spPr>
              <a:xfrm>
                <a:off x="3539160" y="9704880"/>
                <a:ext cx="106164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776240"/>
                    <a:tab algn="l" pos="3552840"/>
                    <a:tab algn="l" pos="5329080"/>
                    <a:tab algn="l" pos="7105680"/>
                    <a:tab algn="l" pos="8881920"/>
                    <a:tab algn="l" pos="1065852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Glycolysis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4" name="Group 42"/>
            <p:cNvGrpSpPr/>
            <p:nvPr/>
          </p:nvGrpSpPr>
          <p:grpSpPr>
            <a:xfrm>
              <a:off x="7808760" y="9727200"/>
              <a:ext cx="5095440" cy="667800"/>
              <a:chOff x="7808760" y="9727200"/>
              <a:chExt cx="5095440" cy="667800"/>
            </a:xfrm>
          </p:grpSpPr>
          <p:sp>
            <p:nvSpPr>
              <p:cNvPr id="55" name="TextBox 35"/>
              <p:cNvSpPr/>
              <p:nvPr/>
            </p:nvSpPr>
            <p:spPr>
              <a:xfrm>
                <a:off x="9328680" y="9727200"/>
                <a:ext cx="188928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776240"/>
                    <a:tab algn="l" pos="3552840"/>
                    <a:tab algn="l" pos="5329080"/>
                    <a:tab algn="l" pos="7105680"/>
                    <a:tab algn="l" pos="8881920"/>
                    <a:tab algn="l" pos="1065852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Glycolytic Capacity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TextBox 36"/>
              <p:cNvSpPr/>
              <p:nvPr/>
            </p:nvSpPr>
            <p:spPr>
              <a:xfrm>
                <a:off x="7808760" y="10106640"/>
                <a:ext cx="688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776240"/>
                    <a:tab algn="l" pos="3552840"/>
                    <a:tab algn="l" pos="5329080"/>
                    <a:tab algn="l" pos="7105680"/>
                    <a:tab algn="l" pos="8881920"/>
                    <a:tab algn="l" pos="1065852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ontrol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TextBox 37"/>
              <p:cNvSpPr/>
              <p:nvPr/>
            </p:nvSpPr>
            <p:spPr>
              <a:xfrm>
                <a:off x="10126800" y="10118520"/>
                <a:ext cx="5097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776240"/>
                    <a:tab algn="l" pos="3552840"/>
                    <a:tab algn="l" pos="5329080"/>
                    <a:tab algn="l" pos="7105680"/>
                    <a:tab algn="l" pos="8881920"/>
                    <a:tab algn="l" pos="1065852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DXR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TextBox 38"/>
              <p:cNvSpPr/>
              <p:nvPr/>
            </p:nvSpPr>
            <p:spPr>
              <a:xfrm>
                <a:off x="12078720" y="10106640"/>
                <a:ext cx="8254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776240"/>
                    <a:tab algn="l" pos="3552840"/>
                    <a:tab algn="l" pos="5329080"/>
                    <a:tab algn="l" pos="7105680"/>
                    <a:tab algn="l" pos="8881920"/>
                    <a:tab algn="l" pos="1065852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TS/DXR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9" name="144 - Ευθεία γραμμή σύνδεσης"/>
            <p:cNvSpPr/>
            <p:nvPr/>
          </p:nvSpPr>
          <p:spPr>
            <a:xfrm flipH="1" flipV="1">
              <a:off x="1055520" y="10052280"/>
              <a:ext cx="5616720" cy="14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3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144 - Ευθεία γραμμή σύνδεσης"/>
            <p:cNvSpPr/>
            <p:nvPr/>
          </p:nvSpPr>
          <p:spPr>
            <a:xfrm flipH="1" flipV="1">
              <a:off x="6956280" y="10053720"/>
              <a:ext cx="6154560" cy="14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3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Box 4"/>
            <p:cNvSpPr/>
            <p:nvPr/>
          </p:nvSpPr>
          <p:spPr>
            <a:xfrm>
              <a:off x="1432800" y="13000320"/>
              <a:ext cx="688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ontr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Box 5"/>
            <p:cNvSpPr/>
            <p:nvPr/>
          </p:nvSpPr>
          <p:spPr>
            <a:xfrm>
              <a:off x="3655800" y="13000320"/>
              <a:ext cx="509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X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Box 6"/>
            <p:cNvSpPr/>
            <p:nvPr/>
          </p:nvSpPr>
          <p:spPr>
            <a:xfrm>
              <a:off x="5701680" y="13000320"/>
              <a:ext cx="825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TS/DX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TextBox 7"/>
            <p:cNvSpPr/>
            <p:nvPr/>
          </p:nvSpPr>
          <p:spPr>
            <a:xfrm>
              <a:off x="3238200" y="12562200"/>
              <a:ext cx="17978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Glycolytic Reserve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144 - Ευθεία γραμμή σύνδεσης"/>
            <p:cNvSpPr/>
            <p:nvPr/>
          </p:nvSpPr>
          <p:spPr>
            <a:xfrm flipH="1" flipV="1">
              <a:off x="1055520" y="12909600"/>
              <a:ext cx="5616720" cy="14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3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6" name="Group 44"/>
            <p:cNvGrpSpPr/>
            <p:nvPr/>
          </p:nvGrpSpPr>
          <p:grpSpPr>
            <a:xfrm>
              <a:off x="7888680" y="12562200"/>
              <a:ext cx="4999680" cy="718920"/>
              <a:chOff x="7888680" y="12562200"/>
              <a:chExt cx="4999680" cy="718920"/>
            </a:xfrm>
          </p:grpSpPr>
          <p:sp>
            <p:nvSpPr>
              <p:cNvPr id="67" name="TextBox 7"/>
              <p:cNvSpPr/>
              <p:nvPr/>
            </p:nvSpPr>
            <p:spPr>
              <a:xfrm>
                <a:off x="7888680" y="13004640"/>
                <a:ext cx="6548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776240"/>
                    <a:tab algn="l" pos="3552840"/>
                    <a:tab algn="l" pos="5329080"/>
                    <a:tab algn="l" pos="7105680"/>
                    <a:tab algn="l" pos="8881920"/>
                    <a:tab algn="l" pos="1065852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Calibri"/>
                  </a:rPr>
                  <a:t>Control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TextBox 8"/>
              <p:cNvSpPr/>
              <p:nvPr/>
            </p:nvSpPr>
            <p:spPr>
              <a:xfrm>
                <a:off x="10112040" y="13004640"/>
                <a:ext cx="446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776240"/>
                    <a:tab algn="l" pos="3552840"/>
                    <a:tab algn="l" pos="5329080"/>
                    <a:tab algn="l" pos="7105680"/>
                    <a:tab algn="l" pos="8881920"/>
                    <a:tab algn="l" pos="1065852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Calibri"/>
                  </a:rPr>
                  <a:t>DXR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TextBox 9"/>
              <p:cNvSpPr/>
              <p:nvPr/>
            </p:nvSpPr>
            <p:spPr>
              <a:xfrm>
                <a:off x="12157560" y="13004640"/>
                <a:ext cx="7308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776240"/>
                    <a:tab algn="l" pos="3552840"/>
                    <a:tab algn="l" pos="5329080"/>
                    <a:tab algn="l" pos="7105680"/>
                    <a:tab algn="l" pos="8881920"/>
                    <a:tab algn="l" pos="1065852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Calibri"/>
                  </a:rPr>
                  <a:t>STS/DXR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TextBox 10"/>
              <p:cNvSpPr/>
              <p:nvPr/>
            </p:nvSpPr>
            <p:spPr>
              <a:xfrm>
                <a:off x="8982000" y="12562200"/>
                <a:ext cx="27043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1776240"/>
                    <a:tab algn="l" pos="3552840"/>
                    <a:tab algn="l" pos="5329080"/>
                    <a:tab algn="l" pos="7105680"/>
                    <a:tab algn="l" pos="8881920"/>
                    <a:tab algn="l" pos="1065852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Non-Glycolytic Acidification 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1" name="144 - Ευθεία γραμμή σύνδεσης"/>
            <p:cNvSpPr/>
            <p:nvPr/>
          </p:nvSpPr>
          <p:spPr>
            <a:xfrm flipH="1" flipV="1">
              <a:off x="7038720" y="12909600"/>
              <a:ext cx="6083280" cy="14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3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42 - TextBox"/>
            <p:cNvSpPr/>
            <p:nvPr/>
          </p:nvSpPr>
          <p:spPr>
            <a:xfrm>
              <a:off x="413640" y="1014120"/>
              <a:ext cx="598320" cy="396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42 - TextBox"/>
            <p:cNvSpPr/>
            <p:nvPr/>
          </p:nvSpPr>
          <p:spPr>
            <a:xfrm>
              <a:off x="416880" y="9511200"/>
              <a:ext cx="598320" cy="396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TextBox 4"/>
            <p:cNvSpPr/>
            <p:nvPr/>
          </p:nvSpPr>
          <p:spPr>
            <a:xfrm>
              <a:off x="3039480" y="1288800"/>
              <a:ext cx="39704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asal Respiration 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TextBox 7"/>
            <p:cNvSpPr/>
            <p:nvPr/>
          </p:nvSpPr>
          <p:spPr>
            <a:xfrm>
              <a:off x="1715400" y="1723680"/>
              <a:ext cx="688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ontr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TextBox 8"/>
            <p:cNvSpPr/>
            <p:nvPr/>
          </p:nvSpPr>
          <p:spPr>
            <a:xfrm>
              <a:off x="3814560" y="1730160"/>
              <a:ext cx="509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X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TextBox 9"/>
            <p:cNvSpPr/>
            <p:nvPr/>
          </p:nvSpPr>
          <p:spPr>
            <a:xfrm>
              <a:off x="5606280" y="1711080"/>
              <a:ext cx="825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TS/DX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TextBox 11"/>
            <p:cNvSpPr/>
            <p:nvPr/>
          </p:nvSpPr>
          <p:spPr>
            <a:xfrm>
              <a:off x="9902880" y="5341320"/>
              <a:ext cx="16560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P  Productio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TextBox 15"/>
            <p:cNvSpPr/>
            <p:nvPr/>
          </p:nvSpPr>
          <p:spPr>
            <a:xfrm>
              <a:off x="8035560" y="5747760"/>
              <a:ext cx="688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ontr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TextBox 17"/>
            <p:cNvSpPr/>
            <p:nvPr/>
          </p:nvSpPr>
          <p:spPr>
            <a:xfrm>
              <a:off x="10346760" y="5747760"/>
              <a:ext cx="509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X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TextBox 19"/>
            <p:cNvSpPr/>
            <p:nvPr/>
          </p:nvSpPr>
          <p:spPr>
            <a:xfrm>
              <a:off x="12412440" y="5747760"/>
              <a:ext cx="825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TS/DX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144 - Ευθεία γραμμή σύνδεσης"/>
            <p:cNvSpPr/>
            <p:nvPr/>
          </p:nvSpPr>
          <p:spPr>
            <a:xfrm flipH="1" flipV="1">
              <a:off x="790200" y="1652400"/>
              <a:ext cx="6083280" cy="14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3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144 - Ευθεία γραμμή σύνδεσης"/>
            <p:cNvSpPr/>
            <p:nvPr/>
          </p:nvSpPr>
          <p:spPr>
            <a:xfrm flipH="1" flipV="1">
              <a:off x="7302600" y="5689440"/>
              <a:ext cx="6083280" cy="14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3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144 - Ευθεία γραμμή σύνδεσης"/>
            <p:cNvSpPr/>
            <p:nvPr/>
          </p:nvSpPr>
          <p:spPr>
            <a:xfrm flipH="1" flipV="1">
              <a:off x="733320" y="5689440"/>
              <a:ext cx="6083280" cy="14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3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TextBox 23"/>
            <p:cNvSpPr/>
            <p:nvPr/>
          </p:nvSpPr>
          <p:spPr>
            <a:xfrm>
              <a:off x="10306080" y="1274400"/>
              <a:ext cx="185400" cy="367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endParaRPr b="0" lang="en-US" sz="3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TextBox 26"/>
            <p:cNvSpPr/>
            <p:nvPr/>
          </p:nvSpPr>
          <p:spPr>
            <a:xfrm>
              <a:off x="10291320" y="1666440"/>
              <a:ext cx="509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X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TextBox 27"/>
            <p:cNvSpPr/>
            <p:nvPr/>
          </p:nvSpPr>
          <p:spPr>
            <a:xfrm>
              <a:off x="12337920" y="1658520"/>
              <a:ext cx="825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TS/DX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TextBox 28"/>
            <p:cNvSpPr/>
            <p:nvPr/>
          </p:nvSpPr>
          <p:spPr>
            <a:xfrm>
              <a:off x="9600120" y="1293480"/>
              <a:ext cx="20764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aximal Respiration 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144 - Ευθεία γραμμή σύνδεσης"/>
            <p:cNvSpPr/>
            <p:nvPr/>
          </p:nvSpPr>
          <p:spPr>
            <a:xfrm flipH="1" flipV="1">
              <a:off x="7343640" y="1650960"/>
              <a:ext cx="6083280" cy="14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3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TextBox 36"/>
            <p:cNvSpPr/>
            <p:nvPr/>
          </p:nvSpPr>
          <p:spPr>
            <a:xfrm>
              <a:off x="2944080" y="5328720"/>
              <a:ext cx="26053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pare Respiratory Capacity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TextBox 38"/>
            <p:cNvSpPr/>
            <p:nvPr/>
          </p:nvSpPr>
          <p:spPr>
            <a:xfrm>
              <a:off x="1601280" y="5757120"/>
              <a:ext cx="688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ontr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TextBox 40"/>
            <p:cNvSpPr/>
            <p:nvPr/>
          </p:nvSpPr>
          <p:spPr>
            <a:xfrm>
              <a:off x="3855240" y="5757120"/>
              <a:ext cx="509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X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TextBox 42"/>
            <p:cNvSpPr/>
            <p:nvPr/>
          </p:nvSpPr>
          <p:spPr>
            <a:xfrm>
              <a:off x="5784120" y="5757120"/>
              <a:ext cx="825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TS/DX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94" name="Picture 1" descr=""/>
            <p:cNvPicPr/>
            <p:nvPr/>
          </p:nvPicPr>
          <p:blipFill>
            <a:blip r:embed="rId1"/>
            <a:stretch/>
          </p:blipFill>
          <p:spPr>
            <a:xfrm>
              <a:off x="1226520" y="10467000"/>
              <a:ext cx="1181160" cy="2095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5" name="Picture 2" descr=""/>
            <p:cNvPicPr/>
            <p:nvPr/>
          </p:nvPicPr>
          <p:blipFill>
            <a:blip r:embed="rId2"/>
            <a:stretch/>
          </p:blipFill>
          <p:spPr>
            <a:xfrm>
              <a:off x="3344400" y="10443240"/>
              <a:ext cx="1288800" cy="2118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6" name="Picture 3" descr=""/>
            <p:cNvPicPr/>
            <p:nvPr/>
          </p:nvPicPr>
          <p:blipFill>
            <a:blip r:embed="rId3"/>
            <a:stretch/>
          </p:blipFill>
          <p:spPr>
            <a:xfrm>
              <a:off x="5384520" y="10430280"/>
              <a:ext cx="1303200" cy="2131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7" name="Picture 4" descr=""/>
            <p:cNvPicPr/>
            <p:nvPr/>
          </p:nvPicPr>
          <p:blipFill>
            <a:blip r:embed="rId4"/>
            <a:stretch/>
          </p:blipFill>
          <p:spPr>
            <a:xfrm>
              <a:off x="11687040" y="10390680"/>
              <a:ext cx="1295280" cy="2171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8" name="Picture 7" descr=""/>
            <p:cNvPicPr/>
            <p:nvPr/>
          </p:nvPicPr>
          <p:blipFill>
            <a:blip r:embed="rId5"/>
            <a:stretch/>
          </p:blipFill>
          <p:spPr>
            <a:xfrm>
              <a:off x="9596160" y="10386000"/>
              <a:ext cx="1266840" cy="2152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9" name="Picture 8" descr=""/>
            <p:cNvPicPr/>
            <p:nvPr/>
          </p:nvPicPr>
          <p:blipFill>
            <a:blip r:embed="rId6"/>
            <a:stretch/>
          </p:blipFill>
          <p:spPr>
            <a:xfrm>
              <a:off x="7343640" y="10384560"/>
              <a:ext cx="1268280" cy="2192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0" name="Picture 9" descr=""/>
            <p:cNvPicPr/>
            <p:nvPr/>
          </p:nvPicPr>
          <p:blipFill>
            <a:blip r:embed="rId7"/>
            <a:stretch/>
          </p:blipFill>
          <p:spPr>
            <a:xfrm>
              <a:off x="1137600" y="13459320"/>
              <a:ext cx="1279440" cy="2139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1" name="Picture 10" descr=""/>
            <p:cNvPicPr/>
            <p:nvPr/>
          </p:nvPicPr>
          <p:blipFill>
            <a:blip r:embed="rId8"/>
            <a:stretch/>
          </p:blipFill>
          <p:spPr>
            <a:xfrm>
              <a:off x="3126960" y="13432320"/>
              <a:ext cx="1279440" cy="2166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2" name="Picture 11" descr=""/>
            <p:cNvPicPr/>
            <p:nvPr/>
          </p:nvPicPr>
          <p:blipFill>
            <a:blip r:embed="rId9"/>
            <a:stretch/>
          </p:blipFill>
          <p:spPr>
            <a:xfrm>
              <a:off x="5320800" y="13386240"/>
              <a:ext cx="1282680" cy="2212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3" name="Picture 15" descr=""/>
            <p:cNvPicPr/>
            <p:nvPr/>
          </p:nvPicPr>
          <p:blipFill>
            <a:blip r:embed="rId10"/>
            <a:stretch/>
          </p:blipFill>
          <p:spPr>
            <a:xfrm>
              <a:off x="904320" y="1999800"/>
              <a:ext cx="1854000" cy="3111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4" name="Picture 20" descr=""/>
            <p:cNvPicPr/>
            <p:nvPr/>
          </p:nvPicPr>
          <p:blipFill>
            <a:blip r:embed="rId11"/>
            <a:stretch/>
          </p:blipFill>
          <p:spPr>
            <a:xfrm>
              <a:off x="7281720" y="1974600"/>
              <a:ext cx="1930320" cy="3136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5" name="TextBox 7"/>
            <p:cNvSpPr/>
            <p:nvPr/>
          </p:nvSpPr>
          <p:spPr>
            <a:xfrm>
              <a:off x="8132400" y="1658520"/>
              <a:ext cx="688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ontr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06" name="Picture 23" descr=""/>
            <p:cNvPicPr/>
            <p:nvPr/>
          </p:nvPicPr>
          <p:blipFill>
            <a:blip r:embed="rId12"/>
            <a:stretch/>
          </p:blipFill>
          <p:spPr>
            <a:xfrm>
              <a:off x="7461000" y="13381560"/>
              <a:ext cx="1338120" cy="2217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7" name="Picture 24" descr=""/>
            <p:cNvPicPr/>
            <p:nvPr/>
          </p:nvPicPr>
          <p:blipFill>
            <a:blip r:embed="rId13"/>
            <a:stretch/>
          </p:blipFill>
          <p:spPr>
            <a:xfrm>
              <a:off x="9617040" y="13305240"/>
              <a:ext cx="1377720" cy="2293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8" name="Picture 25" descr=""/>
            <p:cNvPicPr/>
            <p:nvPr/>
          </p:nvPicPr>
          <p:blipFill>
            <a:blip r:embed="rId14"/>
            <a:stretch/>
          </p:blipFill>
          <p:spPr>
            <a:xfrm>
              <a:off x="11611080" y="13244760"/>
              <a:ext cx="1407960" cy="2354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9" name="Picture 26" descr=""/>
            <p:cNvPicPr/>
            <p:nvPr/>
          </p:nvPicPr>
          <p:blipFill>
            <a:blip r:embed="rId15"/>
            <a:stretch/>
          </p:blipFill>
          <p:spPr>
            <a:xfrm>
              <a:off x="2909160" y="1999800"/>
              <a:ext cx="1854000" cy="3111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0" name="Picture 27" descr=""/>
            <p:cNvPicPr/>
            <p:nvPr/>
          </p:nvPicPr>
          <p:blipFill>
            <a:blip r:embed="rId16"/>
            <a:stretch/>
          </p:blipFill>
          <p:spPr>
            <a:xfrm>
              <a:off x="4854240" y="2101320"/>
              <a:ext cx="1854000" cy="3009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1" name="Picture 28" descr=""/>
            <p:cNvPicPr/>
            <p:nvPr/>
          </p:nvPicPr>
          <p:blipFill>
            <a:blip r:embed="rId17"/>
            <a:stretch/>
          </p:blipFill>
          <p:spPr>
            <a:xfrm>
              <a:off x="9378720" y="2025360"/>
              <a:ext cx="1930320" cy="3085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2" name="Picture 29" descr=""/>
            <p:cNvPicPr/>
            <p:nvPr/>
          </p:nvPicPr>
          <p:blipFill>
            <a:blip r:embed="rId18"/>
            <a:stretch/>
          </p:blipFill>
          <p:spPr>
            <a:xfrm>
              <a:off x="11526840" y="2063160"/>
              <a:ext cx="1930320" cy="3047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3" name="Picture 30" descr=""/>
            <p:cNvPicPr/>
            <p:nvPr/>
          </p:nvPicPr>
          <p:blipFill>
            <a:blip r:embed="rId19"/>
            <a:stretch/>
          </p:blipFill>
          <p:spPr>
            <a:xfrm>
              <a:off x="712080" y="6157080"/>
              <a:ext cx="1930320" cy="3238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4" name="Picture 31" descr=""/>
            <p:cNvPicPr/>
            <p:nvPr/>
          </p:nvPicPr>
          <p:blipFill>
            <a:blip r:embed="rId20"/>
            <a:stretch/>
          </p:blipFill>
          <p:spPr>
            <a:xfrm>
              <a:off x="2861640" y="6246000"/>
              <a:ext cx="1930320" cy="3149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5" name="Picture 32" descr=""/>
            <p:cNvPicPr/>
            <p:nvPr/>
          </p:nvPicPr>
          <p:blipFill>
            <a:blip r:embed="rId21"/>
            <a:stretch/>
          </p:blipFill>
          <p:spPr>
            <a:xfrm>
              <a:off x="4879440" y="6233400"/>
              <a:ext cx="1930320" cy="3161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6" name="Picture 33" descr=""/>
            <p:cNvPicPr/>
            <p:nvPr/>
          </p:nvPicPr>
          <p:blipFill>
            <a:blip r:embed="rId22"/>
            <a:stretch/>
          </p:blipFill>
          <p:spPr>
            <a:xfrm>
              <a:off x="7133760" y="6207840"/>
              <a:ext cx="1854000" cy="3187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7" name="Picture 34" descr=""/>
            <p:cNvPicPr/>
            <p:nvPr/>
          </p:nvPicPr>
          <p:blipFill>
            <a:blip r:embed="rId23"/>
            <a:stretch/>
          </p:blipFill>
          <p:spPr>
            <a:xfrm>
              <a:off x="9347040" y="6284160"/>
              <a:ext cx="1854000" cy="3111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8" name="Picture 35" descr=""/>
            <p:cNvPicPr/>
            <p:nvPr/>
          </p:nvPicPr>
          <p:blipFill>
            <a:blip r:embed="rId24"/>
            <a:stretch/>
          </p:blipFill>
          <p:spPr>
            <a:xfrm>
              <a:off x="11401560" y="6220800"/>
              <a:ext cx="1866960" cy="3174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9" name="Rectangle 29"/>
            <p:cNvSpPr/>
            <p:nvPr/>
          </p:nvSpPr>
          <p:spPr>
            <a:xfrm>
              <a:off x="171360" y="154080"/>
              <a:ext cx="6720120" cy="520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2800" spc="-1" strike="noStrike">
                  <a:solidFill>
                    <a:srgbClr val="000000"/>
                  </a:solidFill>
                  <a:latin typeface="Times New Roman"/>
                  <a:ea typeface="Calibri"/>
                </a:rPr>
                <a:t>Additional file 3: Figure  S3</a:t>
              </a:r>
              <a:endParaRPr b="0" lang="en-US" sz="2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07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11-29T11:22:21Z</dcterms:created>
  <dc:creator>Dell User</dc:creator>
  <dc:description/>
  <dc:language>en-US</dc:language>
  <cp:lastModifiedBy>Priya V.</cp:lastModifiedBy>
  <cp:lastPrinted>2023-01-20T17:09:44Z</cp:lastPrinted>
  <dcterms:modified xsi:type="dcterms:W3CDTF">2023-02-01T04:13:12Z</dcterms:modified>
  <cp:revision>365</cp:revision>
  <dc:subject/>
  <dc:title>PowerPoint Presentation</dc:title>
</cp:coreProperties>
</file>